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6"/>
  </p:notesMasterIdLst>
  <p:sldIdLst>
    <p:sldId id="257" r:id="rId2"/>
    <p:sldId id="258" r:id="rId3"/>
    <p:sldId id="262" r:id="rId4"/>
    <p:sldId id="261" r:id="rId5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196" autoAdjust="0"/>
    <p:restoredTop sz="94660"/>
  </p:normalViewPr>
  <p:slideViewPr>
    <p:cSldViewPr snapToGrid="0">
      <p:cViewPr varScale="1">
        <p:scale>
          <a:sx n="89" d="100"/>
          <a:sy n="89" d="100"/>
        </p:scale>
        <p:origin x="276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DC9DF1-C6CE-4E0C-A8B5-F5ACFE17472A}" type="datetimeFigureOut">
              <a:rPr lang="en-US" smtClean="0"/>
              <a:t>12/16/2021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EC6D6C-A064-4656-9EC4-68DC4F8A42E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89202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D53D-4C4D-49F4-A60F-1F4C53471E23}" type="datetimeFigureOut">
              <a:rPr lang="en-US" smtClean="0"/>
              <a:t>12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A0928-D104-4296-A88C-6B3B6612BCE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3571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D53D-4C4D-49F4-A60F-1F4C53471E23}" type="datetimeFigureOut">
              <a:rPr lang="en-US" smtClean="0"/>
              <a:t>12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A0928-D104-4296-A88C-6B3B6612BCE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8774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D53D-4C4D-49F4-A60F-1F4C53471E23}" type="datetimeFigureOut">
              <a:rPr lang="en-US" smtClean="0"/>
              <a:t>12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A0928-D104-4296-A88C-6B3B6612BCE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4381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D53D-4C4D-49F4-A60F-1F4C53471E23}" type="datetimeFigureOut">
              <a:rPr lang="en-US" smtClean="0"/>
              <a:t>12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A0928-D104-4296-A88C-6B3B6612BCE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90650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D53D-4C4D-49F4-A60F-1F4C53471E23}" type="datetimeFigureOut">
              <a:rPr lang="en-US" smtClean="0"/>
              <a:t>12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A0928-D104-4296-A88C-6B3B6612BCE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9675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D53D-4C4D-49F4-A60F-1F4C53471E23}" type="datetimeFigureOut">
              <a:rPr lang="en-US" smtClean="0"/>
              <a:t>12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A0928-D104-4296-A88C-6B3B6612BCE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63927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D53D-4C4D-49F4-A60F-1F4C53471E23}" type="datetimeFigureOut">
              <a:rPr lang="en-US" smtClean="0"/>
              <a:t>12/16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A0928-D104-4296-A88C-6B3B6612BCE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14017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D53D-4C4D-49F4-A60F-1F4C53471E23}" type="datetimeFigureOut">
              <a:rPr lang="en-US" smtClean="0"/>
              <a:t>12/16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A0928-D104-4296-A88C-6B3B6612BCE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61339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D53D-4C4D-49F4-A60F-1F4C53471E23}" type="datetimeFigureOut">
              <a:rPr lang="en-US" smtClean="0"/>
              <a:t>12/16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A0928-D104-4296-A88C-6B3B6612BCE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1500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D53D-4C4D-49F4-A60F-1F4C53471E23}" type="datetimeFigureOut">
              <a:rPr lang="en-US" smtClean="0"/>
              <a:t>12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A0928-D104-4296-A88C-6B3B6612BCE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09869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AD53D-4C4D-49F4-A60F-1F4C53471E23}" type="datetimeFigureOut">
              <a:rPr lang="en-US" smtClean="0"/>
              <a:t>12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A0928-D104-4296-A88C-6B3B6612BCE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7325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7AD53D-4C4D-49F4-A60F-1F4C53471E23}" type="datetimeFigureOut">
              <a:rPr lang="en-US" smtClean="0"/>
              <a:t>12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5A0928-D104-4296-A88C-6B3B6612BCE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85633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tiff"/><Relationship Id="rId5" Type="http://schemas.openxmlformats.org/officeDocument/2006/relationships/image" Target="../media/image5.tiff"/><Relationship Id="rId4" Type="http://schemas.openxmlformats.org/officeDocument/2006/relationships/image" Target="../media/image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re 1"/>
          <p:cNvSpPr txBox="1">
            <a:spLocks/>
          </p:cNvSpPr>
          <p:nvPr/>
        </p:nvSpPr>
        <p:spPr>
          <a:xfrm>
            <a:off x="88694" y="208462"/>
            <a:ext cx="3388659" cy="512251"/>
          </a:xfrm>
          <a:prstGeom prst="rect">
            <a:avLst/>
          </a:prstGeom>
        </p:spPr>
        <p:txBody>
          <a:bodyPr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fr-FR" sz="24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sz="2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2400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terial</a:t>
            </a:r>
            <a:r>
              <a:rPr lang="fr-FR" sz="24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24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88694" y="1424025"/>
            <a:ext cx="67693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S1: Patient </a:t>
            </a:r>
            <a:r>
              <a:rPr lang="fr-FR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aracterisitics</a:t>
            </a:r>
            <a:r>
              <a:rPr lang="fr-F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Data </a:t>
            </a:r>
            <a:r>
              <a:rPr lang="fr-FR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</a:t>
            </a:r>
            <a:r>
              <a:rPr lang="fr-F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fr-F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s </a:t>
            </a:r>
            <a:r>
              <a:rPr lang="fr-FR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an</a:t>
            </a:r>
            <a:r>
              <a:rPr lang="fr-F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± standard </a:t>
            </a:r>
            <a:r>
              <a:rPr lang="fr-FR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viation</a:t>
            </a:r>
            <a:r>
              <a:rPr lang="fr-F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6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ZoneTexte 5"/>
          <p:cNvSpPr txBox="1"/>
          <p:nvPr/>
        </p:nvSpPr>
        <p:spPr>
          <a:xfrm>
            <a:off x="88694" y="903595"/>
            <a:ext cx="274626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ble 1:</a:t>
            </a:r>
            <a:endParaRPr 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Tableau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51815353"/>
              </p:ext>
            </p:extLst>
          </p:nvPr>
        </p:nvGraphicFramePr>
        <p:xfrm>
          <a:off x="933399" y="2073147"/>
          <a:ext cx="4902506" cy="1726510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1480003">
                  <a:extLst>
                    <a:ext uri="{9D8B030D-6E8A-4147-A177-3AD203B41FA5}">
                      <a16:colId xmlns:a16="http://schemas.microsoft.com/office/drawing/2014/main" val="772615224"/>
                    </a:ext>
                  </a:extLst>
                </a:gridCol>
                <a:gridCol w="1739001">
                  <a:extLst>
                    <a:ext uri="{9D8B030D-6E8A-4147-A177-3AD203B41FA5}">
                      <a16:colId xmlns:a16="http://schemas.microsoft.com/office/drawing/2014/main" val="1010429113"/>
                    </a:ext>
                  </a:extLst>
                </a:gridCol>
                <a:gridCol w="1683502">
                  <a:extLst>
                    <a:ext uri="{9D8B030D-6E8A-4147-A177-3AD203B41FA5}">
                      <a16:colId xmlns:a16="http://schemas.microsoft.com/office/drawing/2014/main" val="2528897673"/>
                    </a:ext>
                  </a:extLst>
                </a:gridCol>
              </a:tblGrid>
              <a:tr h="442155">
                <a:tc>
                  <a:txBody>
                    <a:bodyPr/>
                    <a:lstStyle/>
                    <a:p>
                      <a:pPr lvl="0" algn="ctr" fontAlgn="b"/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lvl="0" algn="ctr" fontAlgn="b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althy aorta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lvl="0" algn="ctr" fontAlgn="b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A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79703830"/>
                  </a:ext>
                </a:extLst>
              </a:tr>
              <a:tr h="421100">
                <a:tc>
                  <a:txBody>
                    <a:bodyPr/>
                    <a:lstStyle/>
                    <a:p>
                      <a:pPr lvl="0" algn="ctr" fontAlgn="b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lvl="0" algn="ctr" fontAlgn="b"/>
                      <a:r>
                        <a:rPr lang="fr-FR" sz="1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lvl="0" algn="ctr" fontAlgn="b"/>
                      <a:r>
                        <a:rPr lang="en-US" sz="18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213815309"/>
                  </a:ext>
                </a:extLst>
              </a:tr>
              <a:tr h="421100">
                <a:tc>
                  <a:txBody>
                    <a:bodyPr/>
                    <a:lstStyle/>
                    <a:p>
                      <a:pPr lvl="0" algn="ctr" fontAlgn="b"/>
                      <a:r>
                        <a:rPr lang="en-US" sz="1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lvl="0" algn="ctr" fontAlgn="b"/>
                      <a:r>
                        <a:rPr lang="en-US" sz="18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.9 ± 9.6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lvl="0" algn="ctr" fontAlgn="b"/>
                      <a:r>
                        <a:rPr lang="en-US" sz="18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.9</a:t>
                      </a:r>
                      <a:r>
                        <a:rPr lang="en-US" sz="1800" u="none" strike="noStrike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17.9 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65238511"/>
                  </a:ext>
                </a:extLst>
              </a:tr>
              <a:tr h="442155">
                <a:tc>
                  <a:txBody>
                    <a:bodyPr/>
                    <a:lstStyle/>
                    <a:p>
                      <a:pPr lvl="0" algn="ctr" fontAlgn="b"/>
                      <a:r>
                        <a:rPr lang="en-US" sz="1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x, % male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lvl="0" algn="ctr" fontAlgn="b"/>
                      <a:r>
                        <a:rPr lang="en-US" sz="18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.37</a:t>
                      </a:r>
                      <a:r>
                        <a:rPr lang="en-US" sz="1800" u="none" strike="noStrike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lvl="0" algn="ctr" fontAlgn="b"/>
                      <a:r>
                        <a:rPr lang="en-US" sz="18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</a:t>
                      </a:r>
                      <a:r>
                        <a:rPr lang="en-US" sz="1800" u="none" strike="noStrike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8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284321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01372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au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13722013"/>
              </p:ext>
            </p:extLst>
          </p:nvPr>
        </p:nvGraphicFramePr>
        <p:xfrm>
          <a:off x="124177" y="1248945"/>
          <a:ext cx="6581424" cy="8356467"/>
        </p:xfrm>
        <a:graphic>
          <a:graphicData uri="http://schemas.openxmlformats.org/drawingml/2006/table">
            <a:tbl>
              <a:tblPr firstRow="1" firstCol="1" bandRow="1">
                <a:tableStyleId>{5202B0CA-FC54-4496-8BCA-5EF66A818D29}</a:tableStyleId>
              </a:tblPr>
              <a:tblGrid>
                <a:gridCol w="1548571">
                  <a:extLst>
                    <a:ext uri="{9D8B030D-6E8A-4147-A177-3AD203B41FA5}">
                      <a16:colId xmlns:a16="http://schemas.microsoft.com/office/drawing/2014/main" val="2114941092"/>
                    </a:ext>
                  </a:extLst>
                </a:gridCol>
                <a:gridCol w="2226581">
                  <a:extLst>
                    <a:ext uri="{9D8B030D-6E8A-4147-A177-3AD203B41FA5}">
                      <a16:colId xmlns:a16="http://schemas.microsoft.com/office/drawing/2014/main" val="2462041123"/>
                    </a:ext>
                  </a:extLst>
                </a:gridCol>
                <a:gridCol w="1354658">
                  <a:extLst>
                    <a:ext uri="{9D8B030D-6E8A-4147-A177-3AD203B41FA5}">
                      <a16:colId xmlns:a16="http://schemas.microsoft.com/office/drawing/2014/main" val="899177086"/>
                    </a:ext>
                  </a:extLst>
                </a:gridCol>
                <a:gridCol w="1451614">
                  <a:extLst>
                    <a:ext uri="{9D8B030D-6E8A-4147-A177-3AD203B41FA5}">
                      <a16:colId xmlns:a16="http://schemas.microsoft.com/office/drawing/2014/main" val="1939559406"/>
                    </a:ext>
                  </a:extLst>
                </a:gridCol>
              </a:tblGrid>
              <a:tr h="33390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gen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lution, host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alog number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pany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/>
                </a:tc>
                <a:extLst>
                  <a:ext uri="{0D108BD9-81ED-4DB2-BD59-A6C34878D82A}">
                    <a16:rowId xmlns:a16="http://schemas.microsoft.com/office/drawing/2014/main" val="292413892"/>
                  </a:ext>
                </a:extLst>
              </a:tr>
              <a:tr h="333908">
                <a:tc gridSpan="4"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ary Ab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98896099"/>
                  </a:ext>
                </a:extLst>
              </a:tr>
              <a:tr h="66721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-Sdc-1 (human IHC)          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20, 10 µg/ml, mouse anti human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-12765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ntacruz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2371227"/>
                  </a:ext>
                </a:extLst>
              </a:tr>
              <a:tr h="66721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-Sdc-1 (human IF)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40, 5 µg/ml, rabbit anti human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5-16918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vitrogen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64635945"/>
                  </a:ext>
                </a:extLst>
              </a:tr>
              <a:tr h="667816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-α-SMA (human IF)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, 0.71 µg/ml mouse anti-human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0851, clone 1A4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ko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22562342"/>
                  </a:ext>
                </a:extLst>
              </a:tr>
              <a:tr h="651717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-Sdc-1 (mice IHC)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500, 1 µg/ml, rat anti mouse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2502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egend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58430354"/>
                  </a:ext>
                </a:extLst>
              </a:tr>
              <a:tr h="33390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-ly6-G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50, 10 µg/ml, rat anti mouse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1459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 pharmingen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3147849"/>
                  </a:ext>
                </a:extLst>
              </a:tr>
              <a:tr h="66721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-CD45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, 8 µg/ml, rabbit anti mouse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10558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cam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76569328"/>
                  </a:ext>
                </a:extLst>
              </a:tr>
              <a:tr h="333908">
                <a:tc gridSpan="4"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ondary Ab /kit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solidFill>
                      <a:schemeClr val="bg2">
                        <a:lumMod val="9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7824380"/>
                  </a:ext>
                </a:extLst>
              </a:tr>
              <a:tr h="667816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AB2 System-HRP (human IHC)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oat anti-mouse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O675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ko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828108"/>
                  </a:ext>
                </a:extLst>
              </a:tr>
              <a:tr h="667816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roxidase </a:t>
                      </a:r>
                      <a:r>
                        <a:rPr lang="en-US" sz="1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ffiniPure</a:t>
                      </a: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mouse IHC)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, Donkey anti rat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12-035-153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ackson ImmunoResearch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98376391"/>
                  </a:ext>
                </a:extLst>
              </a:tr>
              <a:tr h="33390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3 F(ab')2 anti-rat 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/500, 3µg/ml, goat polyclonal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2-166-062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chim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0566634"/>
                  </a:ext>
                </a:extLst>
              </a:tr>
              <a:tr h="66721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3 F(ab')2 anti-rabbit 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/500, 3µg/ml, goat polyclonal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1-166-045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chim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98881186"/>
                  </a:ext>
                </a:extLst>
              </a:tr>
              <a:tr h="66721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5  F(ab')2 anti-mouse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/500, 3µg/ml, goat polyclonal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5-606-062D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chim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66488504"/>
                  </a:ext>
                </a:extLst>
              </a:tr>
              <a:tr h="667215"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5  F(ab')2 anti-rabbit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/500, 3µg/ml, goat polyclonal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1-606-144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chim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275" marR="662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82595262"/>
                  </a:ext>
                </a:extLst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0" y="401381"/>
            <a:ext cx="6705601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</a:t>
            </a:r>
            <a:r>
              <a:rPr lang="en-US" sz="16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Antibodies used for immunohistochemistry and immunofluorescence experiments 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0" y="94821"/>
            <a:ext cx="274626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ble </a:t>
            </a:r>
            <a:r>
              <a:rPr lang="fr-F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:</a:t>
            </a:r>
            <a:endParaRPr 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71049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0" y="257501"/>
            <a:ext cx="285546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1</a:t>
            </a:r>
            <a:r>
              <a:rPr lang="fr-F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endParaRPr 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ZoneTexte 2"/>
          <p:cNvSpPr txBox="1"/>
          <p:nvPr/>
        </p:nvSpPr>
        <p:spPr>
          <a:xfrm>
            <a:off x="2572098" y="1564123"/>
            <a:ext cx="17171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PN+Ang II 3D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ZoneTexte 3"/>
          <p:cNvSpPr txBox="1"/>
          <p:nvPr/>
        </p:nvSpPr>
        <p:spPr>
          <a:xfrm>
            <a:off x="635909" y="1564123"/>
            <a:ext cx="11737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PN </a:t>
            </a:r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ly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ZoneTexte 4"/>
          <p:cNvSpPr txBox="1"/>
          <p:nvPr/>
        </p:nvSpPr>
        <p:spPr>
          <a:xfrm>
            <a:off x="4723295" y="1564123"/>
            <a:ext cx="18309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PN+Ang II 28D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5"/>
          <p:cNvSpPr/>
          <p:nvPr/>
        </p:nvSpPr>
        <p:spPr>
          <a:xfrm flipV="1">
            <a:off x="1155269" y="1478288"/>
            <a:ext cx="4674708" cy="4571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2959208" y="1083717"/>
            <a:ext cx="10668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TAA</a:t>
            </a: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 Box 6"/>
          <p:cNvSpPr txBox="1">
            <a:spLocks noChangeArrowheads="1"/>
          </p:cNvSpPr>
          <p:nvPr/>
        </p:nvSpPr>
        <p:spPr bwMode="auto">
          <a:xfrm>
            <a:off x="115888" y="3671764"/>
            <a:ext cx="6541386" cy="1815882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defTabSz="914383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600" u="sng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 </a:t>
            </a:r>
            <a:endParaRPr lang="en-US" altLang="en-US" sz="1600" u="sng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914383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6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dc-1 is not detected in non TAA aortas treated with BAPN only or in combination with </a:t>
            </a:r>
            <a:r>
              <a:rPr lang="en-US" altLang="en-US" sz="1600" b="1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g</a:t>
            </a:r>
            <a:r>
              <a:rPr lang="en-US" altLang="en-US" sz="16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I </a:t>
            </a: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6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presentative images of IHC experiment targeting Sdc-1. Scale bar corresponding to 50 µm. BAPN only </a:t>
            </a:r>
            <a:r>
              <a:rPr lang="en-US" altLang="en-US" sz="1600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=2, </a:t>
            </a:r>
            <a:r>
              <a:rPr lang="en-US" altLang="en-US" sz="16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PN+Ang</a:t>
            </a:r>
            <a:r>
              <a:rPr lang="en-US" altLang="en-US" sz="16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I (3 or 28D):</a:t>
            </a:r>
            <a:r>
              <a:rPr lang="en-US" altLang="en-US" sz="1600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=3</a:t>
            </a:r>
            <a:endParaRPr lang="en-US" altLang="en-US" sz="16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600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US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Image 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560" y="1906227"/>
            <a:ext cx="6476714" cy="15860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28991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23" t="5320" r="2121" b="69594"/>
          <a:stretch/>
        </p:blipFill>
        <p:spPr>
          <a:xfrm>
            <a:off x="1842452" y="1035925"/>
            <a:ext cx="4755872" cy="1562554"/>
          </a:xfrm>
          <a:prstGeom prst="rect">
            <a:avLst/>
          </a:prstGeom>
        </p:spPr>
      </p:pic>
      <p:pic>
        <p:nvPicPr>
          <p:cNvPr id="3" name="Image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9" t="74673" r="2500" b="837"/>
          <a:stretch/>
        </p:blipFill>
        <p:spPr>
          <a:xfrm>
            <a:off x="1799576" y="6608669"/>
            <a:ext cx="4755872" cy="1525700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2679"/>
          <a:stretch/>
        </p:blipFill>
        <p:spPr>
          <a:xfrm>
            <a:off x="504364" y="998532"/>
            <a:ext cx="1207192" cy="3378250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817"/>
          <a:stretch/>
        </p:blipFill>
        <p:spPr>
          <a:xfrm>
            <a:off x="504364" y="4871015"/>
            <a:ext cx="1179040" cy="3309103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23" t="32861" r="2121" b="42445"/>
          <a:stretch/>
        </p:blipFill>
        <p:spPr>
          <a:xfrm>
            <a:off x="1827728" y="2801932"/>
            <a:ext cx="4755872" cy="1538098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9" t="48854" r="2500" b="26310"/>
          <a:stretch/>
        </p:blipFill>
        <p:spPr>
          <a:xfrm>
            <a:off x="1819476" y="4871015"/>
            <a:ext cx="4755872" cy="1547263"/>
          </a:xfrm>
          <a:prstGeom prst="rect">
            <a:avLst/>
          </a:prstGeom>
        </p:spPr>
      </p:pic>
      <p:sp>
        <p:nvSpPr>
          <p:cNvPr id="9" name="Zone de texte 2"/>
          <p:cNvSpPr txBox="1">
            <a:spLocks noChangeArrowheads="1"/>
          </p:cNvSpPr>
          <p:nvPr/>
        </p:nvSpPr>
        <p:spPr bwMode="auto">
          <a:xfrm>
            <a:off x="31153" y="440940"/>
            <a:ext cx="2468354" cy="326351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defTabSz="914383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fr-FR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BAPN+ Ang II </a:t>
            </a:r>
            <a:r>
              <a:rPr lang="fr-FR" alt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D</a:t>
            </a:r>
            <a:endParaRPr lang="en-US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ZoneTexte 9"/>
          <p:cNvSpPr txBox="1"/>
          <p:nvPr/>
        </p:nvSpPr>
        <p:spPr>
          <a:xfrm>
            <a:off x="133298" y="1433608"/>
            <a:ext cx="430887" cy="76399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dc-1</a:t>
            </a:r>
            <a:r>
              <a:rPr lang="fr-FR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/+</a:t>
            </a:r>
            <a:endParaRPr lang="en-US" sz="16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ZoneTexte 10"/>
          <p:cNvSpPr txBox="1"/>
          <p:nvPr/>
        </p:nvSpPr>
        <p:spPr>
          <a:xfrm>
            <a:off x="133298" y="3215610"/>
            <a:ext cx="430887" cy="69987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dc-1</a:t>
            </a:r>
            <a:r>
              <a:rPr lang="fr-FR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lang="en-US" sz="16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133298" y="5262650"/>
            <a:ext cx="430887" cy="76399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dc-1</a:t>
            </a:r>
            <a:r>
              <a:rPr lang="fr-FR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/+</a:t>
            </a:r>
            <a:endParaRPr lang="en-US" sz="16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133298" y="7017510"/>
            <a:ext cx="430887" cy="69987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dc-1</a:t>
            </a:r>
            <a:r>
              <a:rPr lang="fr-FR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endParaRPr lang="en-US" sz="16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Zone de texte 2"/>
          <p:cNvSpPr txBox="1">
            <a:spLocks noChangeArrowheads="1"/>
          </p:cNvSpPr>
          <p:nvPr/>
        </p:nvSpPr>
        <p:spPr bwMode="auto">
          <a:xfrm>
            <a:off x="-46624" y="4395409"/>
            <a:ext cx="2291787" cy="326351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defTabSz="914383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fr-FR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BAPN+ Ang II </a:t>
            </a:r>
            <a:r>
              <a:rPr lang="fr-FR" alt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8D</a:t>
            </a:r>
            <a:endParaRPr lang="en-US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ZoneTexte 14"/>
          <p:cNvSpPr txBox="1"/>
          <p:nvPr/>
        </p:nvSpPr>
        <p:spPr>
          <a:xfrm>
            <a:off x="3424555" y="832471"/>
            <a:ext cx="16639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dirty="0" err="1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eutrophils</a:t>
            </a:r>
            <a:r>
              <a:rPr lang="fr-FR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4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Ly-6G</a:t>
            </a:r>
            <a:r>
              <a:rPr lang="fr-FR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4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ZoneTexte 15"/>
          <p:cNvSpPr txBox="1"/>
          <p:nvPr/>
        </p:nvSpPr>
        <p:spPr>
          <a:xfrm>
            <a:off x="1818026" y="832472"/>
            <a:ext cx="16065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dirty="0" err="1" smtClean="0">
                <a:solidFill>
                  <a:schemeClr val="accent4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eukocytes</a:t>
            </a:r>
            <a:r>
              <a:rPr lang="fr-FR" sz="1400" dirty="0">
                <a:solidFill>
                  <a:schemeClr val="accent4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400" dirty="0" smtClean="0">
                <a:solidFill>
                  <a:schemeClr val="accent4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CD45</a:t>
            </a:r>
            <a:r>
              <a:rPr lang="fr-FR" sz="1400" dirty="0">
                <a:solidFill>
                  <a:schemeClr val="accent4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400" dirty="0">
              <a:solidFill>
                <a:schemeClr val="accent4">
                  <a:lumMod val="7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ZoneTexte 16"/>
          <p:cNvSpPr txBox="1"/>
          <p:nvPr/>
        </p:nvSpPr>
        <p:spPr>
          <a:xfrm>
            <a:off x="5376942" y="832470"/>
            <a:ext cx="7408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rged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 Box 6"/>
          <p:cNvSpPr txBox="1">
            <a:spLocks noChangeArrowheads="1"/>
          </p:cNvSpPr>
          <p:nvPr/>
        </p:nvSpPr>
        <p:spPr bwMode="auto">
          <a:xfrm>
            <a:off x="-208363" y="-16569"/>
            <a:ext cx="3162578" cy="400110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algn="ctr" defTabSz="914383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2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</a:t>
            </a:r>
          </a:p>
        </p:txBody>
      </p:sp>
      <p:sp>
        <p:nvSpPr>
          <p:cNvPr id="20" name="Rectangle 19"/>
          <p:cNvSpPr/>
          <p:nvPr/>
        </p:nvSpPr>
        <p:spPr>
          <a:xfrm>
            <a:off x="941882" y="2233148"/>
            <a:ext cx="182880" cy="182880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5"/>
          </a:p>
        </p:txBody>
      </p:sp>
      <p:sp>
        <p:nvSpPr>
          <p:cNvPr id="21" name="Rectangle 20"/>
          <p:cNvSpPr/>
          <p:nvPr/>
        </p:nvSpPr>
        <p:spPr>
          <a:xfrm>
            <a:off x="586340" y="3052834"/>
            <a:ext cx="182880" cy="182880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5"/>
          </a:p>
        </p:txBody>
      </p:sp>
      <p:sp>
        <p:nvSpPr>
          <p:cNvPr id="22" name="Rectangle 21"/>
          <p:cNvSpPr/>
          <p:nvPr/>
        </p:nvSpPr>
        <p:spPr>
          <a:xfrm>
            <a:off x="955257" y="5510487"/>
            <a:ext cx="182880" cy="182880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5"/>
          </a:p>
        </p:txBody>
      </p:sp>
      <p:sp>
        <p:nvSpPr>
          <p:cNvPr id="23" name="Rectangle 22"/>
          <p:cNvSpPr/>
          <p:nvPr/>
        </p:nvSpPr>
        <p:spPr>
          <a:xfrm>
            <a:off x="865284" y="7724046"/>
            <a:ext cx="182880" cy="182880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5"/>
          </a:p>
        </p:txBody>
      </p:sp>
      <p:sp>
        <p:nvSpPr>
          <p:cNvPr id="24" name="Text Box 6"/>
          <p:cNvSpPr txBox="1">
            <a:spLocks noChangeArrowheads="1"/>
          </p:cNvSpPr>
          <p:nvPr/>
        </p:nvSpPr>
        <p:spPr bwMode="auto">
          <a:xfrm>
            <a:off x="153862" y="8289718"/>
            <a:ext cx="6541386" cy="1815882"/>
          </a:xfrm>
          <a:prstGeom prst="rect">
            <a:avLst/>
          </a:prstGeom>
          <a:noFill/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defTabSz="914383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 u="sng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 </a:t>
            </a:r>
            <a:endParaRPr lang="en-US" altLang="en-US" sz="1400" u="sng" dirty="0" smtClean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defTabSz="914383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en-US" sz="1400" u="sng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dc-1 is dispensable for leukocyte (or neutrophils) recruitment in TAA aortas in the BAPN/Ang II model ((A) 3 or (B) 28 days after Ang II treatment)</a:t>
            </a: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presentative images of IF experiment targeting leukocyte (CD45) or neutrophils (ly-6G). (A, B) Scale bar corresponds to 500 µm for 2-channel images showing whole aorta (to the left) and 50µm for magnified images. </a:t>
            </a:r>
            <a:endParaRPr lang="en-US" altLang="en-US" sz="14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US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045440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4</TotalTime>
  <Words>405</Words>
  <Application>Microsoft Office PowerPoint</Application>
  <PresentationFormat>Format A4 (210 x 297 mm)</PresentationFormat>
  <Paragraphs>95</Paragraphs>
  <Slides>4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enjamin Richard</dc:creator>
  <cp:lastModifiedBy>Benjamin Richard</cp:lastModifiedBy>
  <cp:revision>24</cp:revision>
  <dcterms:created xsi:type="dcterms:W3CDTF">2021-12-07T13:30:06Z</dcterms:created>
  <dcterms:modified xsi:type="dcterms:W3CDTF">2021-12-16T15:23:29Z</dcterms:modified>
</cp:coreProperties>
</file>